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6858000" cy="9144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70" d="100"/>
          <a:sy n="170" d="100"/>
        </p:scale>
        <p:origin x="-1302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2F7-1D1F-479F-8840-BA4D799A8034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36E65-F1F9-48F5-AA9E-9621597446B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2F7-1D1F-479F-8840-BA4D799A8034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36E65-F1F9-48F5-AA9E-9621597446B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2F7-1D1F-479F-8840-BA4D799A8034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36E65-F1F9-48F5-AA9E-9621597446B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2F7-1D1F-479F-8840-BA4D799A8034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36E65-F1F9-48F5-AA9E-9621597446B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2F7-1D1F-479F-8840-BA4D799A8034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36E65-F1F9-48F5-AA9E-9621597446B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2F7-1D1F-479F-8840-BA4D799A8034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36E65-F1F9-48F5-AA9E-9621597446B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2F7-1D1F-479F-8840-BA4D799A8034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36E65-F1F9-48F5-AA9E-9621597446B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2F7-1D1F-479F-8840-BA4D799A8034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36E65-F1F9-48F5-AA9E-9621597446B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2F7-1D1F-479F-8840-BA4D799A8034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36E65-F1F9-48F5-AA9E-9621597446B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2F7-1D1F-479F-8840-BA4D799A8034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36E65-F1F9-48F5-AA9E-9621597446B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2F7-1D1F-479F-8840-BA4D799A8034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36E65-F1F9-48F5-AA9E-9621597446B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D952F7-1D1F-479F-8840-BA4D799A8034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F36E65-F1F9-48F5-AA9E-9621597446B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3"/>
          <p:cNvSpPr txBox="1">
            <a:spLocks noChangeArrowheads="1"/>
          </p:cNvSpPr>
          <p:nvPr/>
        </p:nvSpPr>
        <p:spPr bwMode="auto">
          <a:xfrm>
            <a:off x="2500306" y="71406"/>
            <a:ext cx="4298950" cy="325438"/>
          </a:xfrm>
          <a:prstGeom prst="rect">
            <a:avLst/>
          </a:prstGeom>
          <a:solidFill>
            <a:srgbClr val="FFFFFF"/>
          </a:solidFill>
          <a:ln w="9525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just" fontAlgn="base">
              <a:spcBef>
                <a:spcPct val="0"/>
              </a:spcBef>
              <a:spcAft>
                <a:spcPts val="1000"/>
              </a:spcAft>
            </a:pP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Coelho et al. A protocol for an interventional study on the impact of </a:t>
            </a:r>
            <a:r>
              <a:rPr lang="en-US" sz="700" dirty="0" err="1" smtClean="0">
                <a:latin typeface="Times New Roman" pitchFamily="18" charset="0"/>
                <a:cs typeface="Arial" pitchFamily="34" charset="0"/>
              </a:rPr>
              <a:t>transcutaneous</a:t>
            </a: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 </a:t>
            </a:r>
            <a:r>
              <a:rPr lang="en-US" sz="700" dirty="0" err="1" smtClean="0">
                <a:latin typeface="Times New Roman" pitchFamily="18" charset="0"/>
                <a:cs typeface="Arial" pitchFamily="34" charset="0"/>
              </a:rPr>
              <a:t>parasacral</a:t>
            </a: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 nerve stimulation in children with functional constipation.</a:t>
            </a:r>
          </a:p>
          <a:p>
            <a:pPr algn="just" fontAlgn="base">
              <a:spcBef>
                <a:spcPct val="0"/>
              </a:spcBef>
              <a:spcAft>
                <a:spcPts val="1000"/>
              </a:spcAft>
            </a:pP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Retângulo 2"/>
          <p:cNvSpPr/>
          <p:nvPr/>
        </p:nvSpPr>
        <p:spPr>
          <a:xfrm>
            <a:off x="2000240" y="500034"/>
            <a:ext cx="2767104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pt-B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Supplemental Digital Content - </a:t>
            </a:r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1</a:t>
            </a:r>
            <a:endParaRPr lang="pt-BR" sz="1600" b="1" dirty="0">
              <a:solidFill>
                <a:srgbClr val="C00000"/>
              </a:solidFill>
              <a:latin typeface="Arial Narrow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00108" y="1428728"/>
            <a:ext cx="5035842" cy="73581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Retângulo 5"/>
          <p:cNvSpPr/>
          <p:nvPr/>
        </p:nvSpPr>
        <p:spPr>
          <a:xfrm>
            <a:off x="1643050" y="928662"/>
            <a:ext cx="4278735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pt-B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600" b="1" dirty="0" smtClean="0">
                <a:latin typeface="Arial Narrow" pitchFamily="34" charset="0"/>
              </a:rPr>
              <a:t>Approval by the Research Ethics Committee (REC) </a:t>
            </a:r>
            <a:endParaRPr lang="pt-BR" sz="1600" b="1" dirty="0">
              <a:latin typeface="Arial Narrow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81025" y="471488"/>
            <a:ext cx="5695950" cy="820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71480" y="357158"/>
            <a:ext cx="5959941" cy="81343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23888" y="542925"/>
            <a:ext cx="5610225" cy="8058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8</Words>
  <Application>Microsoft Office PowerPoint</Application>
  <PresentationFormat>Apresentação na tela (4:3)</PresentationFormat>
  <Paragraphs>3</Paragraphs>
  <Slides>4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4</vt:i4>
      </vt:variant>
    </vt:vector>
  </HeadingPairs>
  <TitlesOfParts>
    <vt:vector size="5" baseType="lpstr">
      <vt:lpstr>Tema do Office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edro</dc:creator>
  <cp:lastModifiedBy>Pedro</cp:lastModifiedBy>
  <cp:revision>11</cp:revision>
  <dcterms:created xsi:type="dcterms:W3CDTF">2019-01-18T17:55:12Z</dcterms:created>
  <dcterms:modified xsi:type="dcterms:W3CDTF">2020-10-08T17:45:25Z</dcterms:modified>
</cp:coreProperties>
</file>